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0" d="100"/>
          <a:sy n="120" d="100"/>
        </p:scale>
        <p:origin x="2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6E58A-BC15-9CA0-BFA2-CE5CD7FBCE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4DC6F44-E070-9EFA-5BD4-27BE23310C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1E6F18-9A7A-4140-9EFD-6FA4E4BE5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4A309F-B4B7-1974-D618-0AACEFA96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44D369-0C9F-283A-0617-6D24BF2D3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541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4EB3FE-681F-4BCF-EB28-6B4B288FC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8267EC-CFB0-905D-D913-2CCAABAC77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9E954F-6B5F-278A-EF22-FA7246B42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A6DB0F-AEBE-2E45-772B-1D79DD81C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596540-4A93-EEB6-A6C7-F3F99B15E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039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EEF4CC-D5F2-C446-E10F-9FC2E39A0D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AE1482-B4AA-740E-A0F2-46CF0B82BF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DEEE58-B89B-733D-690B-8D93CC045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998F1-049F-B0DD-28A7-EF3347B50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6B6CBE-F5AD-687D-3F81-3CFA72689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633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49984D-306F-E2F1-0294-C27B9EEE88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291F7D-62D8-B134-F19B-BAC1F69183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C81835-9C2D-5EED-E054-ABCAA9585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D5AEEE-7678-B861-B746-F13964392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2B5627-76A2-8407-4EA2-5A8875F28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465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FF0FEA-B0C9-C5B2-BD91-38C249B2B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5E81F2-25D7-705F-054F-1BABB47778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67881D-C85A-D141-4A5E-4AE924EF3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5BBA63-2D8F-2958-F374-BB1289F8D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12FD4-94A5-70E3-E11D-55EF33334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840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818C62-3A71-8E28-8BCF-58238E2834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178E55-C803-90E0-EA70-639B506C70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D17F79-301C-87AD-8214-75FC8867D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D6A9B0-AF5F-33FA-9B12-F306D75C7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69AECC-5F47-7A8C-B484-081B3FE2E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9180F9-747A-5E97-06E8-2BFFFCA456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877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94EEBF-1CD9-D371-A4EC-65C2434594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691D7B-2D67-E65A-B9F8-A615505106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DE2C44-9767-65F2-CC4F-ED7BD65CDD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EEAF8AD-9AAE-95A6-02A4-331956539B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9050FA-E126-5734-3BE4-95CC6A42FB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042EFE-0336-1554-B28F-7725FB746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48D713-C79F-1430-8F08-49464621D6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777D688-5D67-012A-B43C-058498152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8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77F92-836D-72B9-4FA1-5E76C24695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149D81-1185-BF09-8D59-DD8F74D2B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DDD2A5-342E-F0EB-E73D-CA6899924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B9D411-80EA-8114-BCC9-CED42FC77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37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933DAF-2BB6-8606-B8D9-0D2D6E758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187743C-7F5C-29B3-9DC3-8394DBCDD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16748B-EBE2-0B2F-98FD-D93A9DE98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773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9A5091-C57E-CF01-C3BE-812B19BC42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2180EA-4180-ECAC-3483-290FCFBC1E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4DE29F-1E3F-84DF-2F71-ABA30CFCA9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99CB26-47E4-B8B7-4DE1-B28E3A20B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24AF22-5C18-6B9A-C52B-7D5BF66AE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DFD2C1-53DD-D1BB-CAA6-BC864E3B7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767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8BD33-FEB3-396B-D1FB-DB8035BC1D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3495117-DF2C-6E87-D327-949DEB3BD4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D4B928-6828-74E6-2C06-8F43AC0BF1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CFF453-1161-1EE8-3FA5-EEA5DD2EC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51B614-8369-FEF0-75DF-FB3DF55AF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C726EE-CA0E-942C-BA27-F029A43B9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524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0FD038-A817-17C5-12EE-8306BB30A9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9308CE-E237-05D6-88AD-3E91DF56B6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E1A7C2-408F-5585-B2FE-06EFF33EE2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8F9F0F-05C3-0541-B6CB-02198642052C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3B34A2-F756-5A44-BC1C-2945CCE8DF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8C092-3966-ABB5-D60F-BFA2347F65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DA941F-12BA-6746-9586-8B785BE6F9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961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4B94948-3433-9BA9-5E54-93D64B8179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3580" y="-4004"/>
            <a:ext cx="5404840" cy="612334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0D2F62A-B3BF-B635-ED49-2A9CF0DE37B6}"/>
              </a:ext>
            </a:extLst>
          </p:cNvPr>
          <p:cNvSpPr txBox="1"/>
          <p:nvPr/>
        </p:nvSpPr>
        <p:spPr>
          <a:xfrm>
            <a:off x="0" y="6119336"/>
            <a:ext cx="1217153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fontAlgn="base">
              <a:buNone/>
            </a:pPr>
            <a:r>
              <a:rPr lang="en-US" sz="14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Figure S4: Gating strategy and flow plots for hFlex3a2_v2 </a:t>
            </a:r>
            <a:r>
              <a:rPr lang="en-US" sz="1400" b="1" i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 </a:t>
            </a:r>
            <a:r>
              <a:rPr lang="en-US" sz="14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a surface stains. 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(A) Representative plot showing the gating strategy for identifying the proportion of bacteria that are BV421 positive, indicating that they have been bound by the hFlex3a2_v2 variant tested. (B) Histograms showing surface staining of all hFlex3a2_v2 variants at 4 concentrations against </a:t>
            </a:r>
            <a:r>
              <a:rPr lang="en-US" sz="1400" i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 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a.</a:t>
            </a:r>
            <a:r>
              <a:rPr lang="en-US" sz="14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This experiment is the result of three biological replicates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5101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yden Schmidt</dc:creator>
  <cp:lastModifiedBy>Hayden Schmidt</cp:lastModifiedBy>
  <cp:revision>1</cp:revision>
  <dcterms:created xsi:type="dcterms:W3CDTF">2026-02-19T23:45:39Z</dcterms:created>
  <dcterms:modified xsi:type="dcterms:W3CDTF">2026-02-19T23:46:03Z</dcterms:modified>
</cp:coreProperties>
</file>